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6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TNNA1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1 4igg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igg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14348" y="357167"/>
            <a:ext cx="2857520" cy="29711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285728"/>
            <a:ext cx="2888915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922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14348" y="3392732"/>
            <a:ext cx="2857520" cy="26080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2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286124"/>
            <a:ext cx="2928958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2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0</cp:revision>
  <dcterms:created xsi:type="dcterms:W3CDTF">2018-05-10T07:33:24Z</dcterms:created>
  <dcterms:modified xsi:type="dcterms:W3CDTF">2018-05-29T06:55:52Z</dcterms:modified>
</cp:coreProperties>
</file>